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5968" r:id="rId2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07" d="100"/>
          <a:sy n="107" d="100"/>
        </p:scale>
        <p:origin x="32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002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386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332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676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82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047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088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41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271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411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722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829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25ABA0-67F3-F745-B687-7D15C0969BFB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748452-65C6-F448-9698-6D96287E77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333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microsoft.com/office/2007/relationships/hdphoto" Target="../media/hdphoto12.wdp"/><Relationship Id="rId21" Type="http://schemas.openxmlformats.org/officeDocument/2006/relationships/image" Target="../media/image11.png"/><Relationship Id="rId34" Type="http://schemas.microsoft.com/office/2007/relationships/hdphoto" Target="../media/hdphoto16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openxmlformats.org/officeDocument/2006/relationships/image" Target="../media/image13.png"/><Relationship Id="rId33" Type="http://schemas.openxmlformats.org/officeDocument/2006/relationships/image" Target="../media/image17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microsoft.com/office/2007/relationships/hdphoto" Target="../media/hdphoto9.wdp"/><Relationship Id="rId29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20.emf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openxmlformats.org/officeDocument/2006/relationships/image" Target="../media/image12.png"/><Relationship Id="rId28" Type="http://schemas.microsoft.com/office/2007/relationships/hdphoto" Target="../media/hdphoto13.wdp"/><Relationship Id="rId36" Type="http://schemas.openxmlformats.org/officeDocument/2006/relationships/image" Target="../media/image19.emf"/><Relationship Id="rId10" Type="http://schemas.openxmlformats.org/officeDocument/2006/relationships/image" Target="../media/image5.png"/><Relationship Id="rId19" Type="http://schemas.openxmlformats.org/officeDocument/2006/relationships/image" Target="../media/image10.png"/><Relationship Id="rId31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microsoft.com/office/2007/relationships/hdphoto" Target="../media/hdphoto10.wdp"/><Relationship Id="rId27" Type="http://schemas.openxmlformats.org/officeDocument/2006/relationships/image" Target="../media/image14.png"/><Relationship Id="rId30" Type="http://schemas.microsoft.com/office/2007/relationships/hdphoto" Target="../media/hdphoto14.wdp"/><Relationship Id="rId35" Type="http://schemas.openxmlformats.org/officeDocument/2006/relationships/image" Target="../media/image18.png"/><Relationship Id="rId8" Type="http://schemas.openxmlformats.org/officeDocument/2006/relationships/image" Target="../media/image4.pn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19D2BAE7-B9C3-C54A-D305-F22A2EBCB326}"/>
              </a:ext>
            </a:extLst>
          </p:cNvPr>
          <p:cNvGrpSpPr/>
          <p:nvPr/>
        </p:nvGrpSpPr>
        <p:grpSpPr>
          <a:xfrm>
            <a:off x="109426" y="1900451"/>
            <a:ext cx="1020990" cy="911167"/>
            <a:chOff x="3104629" y="4202930"/>
            <a:chExt cx="1635543" cy="1459613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561888E-2A17-C1CB-5153-F1EB0E4068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51402" b="79252" l="14516" r="72457">
                          <a14:foregroundMark x1="14764" y1="72897" x2="18983" y2="71028"/>
                          <a14:foregroundMark x1="18983" y1="71028" x2="18983" y2="71028"/>
                          <a14:foregroundMark x1="65509" y1="58879" x2="72457" y2="69159"/>
                          <a14:foregroundMark x1="68238" y1="51402" x2="61042" y2="53458"/>
                        </a14:backgroundRemoval>
                      </a14:imgEffect>
                    </a14:imgLayer>
                  </a14:imgProps>
                </a:ext>
              </a:extLst>
            </a:blip>
            <a:srcRect l="14248" t="50199" r="25595" b="16971"/>
            <a:stretch/>
          </p:blipFill>
          <p:spPr>
            <a:xfrm>
              <a:off x="3173153" y="5015480"/>
              <a:ext cx="769855" cy="311715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3DD86CBF-6756-71C2-1EC7-989BFF1AE2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47103" b="79252" l="10050" r="69603">
                          <a14:foregroundMark x1="15757" y1="65794" x2="12779" y2="54019"/>
                          <a14:foregroundMark x1="12655" y1="52710" x2="10050" y2="55514"/>
                          <a14:foregroundMark x1="16005" y1="50654" x2="22953" y2="47103"/>
                          <a14:foregroundMark x1="22953" y1="47103" x2="23201" y2="47103"/>
                          <a14:foregroundMark x1="36849" y1="79065" x2="44293" y2="80187"/>
                          <a14:foregroundMark x1="44293" y1="80187" x2="51489" y2="79439"/>
                          <a14:foregroundMark x1="51489" y1="79439" x2="56948" y2="79439"/>
                          <a14:foregroundMark x1="61290" y1="77196" x2="68238" y2="76449"/>
                          <a14:foregroundMark x1="68238" y1="76449" x2="69603" y2="76449"/>
                        </a14:backgroundRemoval>
                      </a14:imgEffect>
                    </a14:imgLayer>
                  </a14:imgProps>
                </a:ext>
              </a:extLst>
            </a:blip>
            <a:srcRect l="8277" t="44237" r="28140" b="17201"/>
            <a:stretch/>
          </p:blipFill>
          <p:spPr>
            <a:xfrm>
              <a:off x="3925137" y="4956440"/>
              <a:ext cx="815035" cy="366748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72A82B1D-96CA-A53E-A832-33D3F70AED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42430" b="78318" l="13896" r="72953">
                          <a14:foregroundMark x1="18486" y1="60935" x2="16749" y2="68411"/>
                          <a14:foregroundMark x1="15012" y1="72150" x2="14640" y2="73084"/>
                          <a14:foregroundMark x1="34491" y1="75327" x2="40571" y2="78318"/>
                          <a14:foregroundMark x1="61663" y1="72150" x2="69727" y2="75327"/>
                          <a14:foregroundMark x1="64516" y1="44486" x2="64268" y2="42430"/>
                          <a14:foregroundMark x1="70347" y1="73271" x2="72953" y2="71776"/>
                          <a14:foregroundMark x1="13896" y1="75140" x2="13896" y2="75140"/>
                        </a14:backgroundRemoval>
                      </a14:imgEffect>
                    </a14:imgLayer>
                  </a14:imgProps>
                </a:ext>
              </a:extLst>
            </a:blip>
            <a:srcRect l="12459" t="39349" r="26039" b="18679"/>
            <a:stretch/>
          </p:blipFill>
          <p:spPr>
            <a:xfrm>
              <a:off x="3175289" y="4586221"/>
              <a:ext cx="738777" cy="374062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32B0ED14-B55C-3C0D-9A15-E18838F158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ackgroundRemoval t="52336" b="83178" l="16005" r="61290">
                          <a14:foregroundMark x1="29156" y1="57570" x2="23697" y2="53271"/>
                          <a14:foregroundMark x1="23697" y1="53271" x2="18859" y2="55514"/>
                          <a14:foregroundMark x1="22581" y1="54953" x2="18238" y2="60000"/>
                          <a14:foregroundMark x1="18238" y1="60000" x2="16253" y2="69720"/>
                          <a14:foregroundMark x1="21340" y1="78505" x2="27419" y2="81495"/>
                          <a14:foregroundMark x1="27419" y1="81495" x2="27792" y2="81495"/>
                          <a14:foregroundMark x1="54467" y1="75888" x2="59429" y2="77383"/>
                          <a14:foregroundMark x1="59677" y1="77383" x2="61414" y2="77196"/>
                          <a14:foregroundMark x1="34615" y1="83178" x2="38834" y2="82991"/>
                        </a14:backgroundRemoval>
                      </a14:imgEffect>
                    </a14:imgLayer>
                  </a14:imgProps>
                </a:ext>
              </a:extLst>
            </a:blip>
            <a:srcRect l="14209" t="53336" r="38139" b="15821"/>
            <a:stretch/>
          </p:blipFill>
          <p:spPr>
            <a:xfrm>
              <a:off x="3927321" y="4592605"/>
              <a:ext cx="754828" cy="362488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44448EA-3536-509D-B6BB-D36AB1BCB5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47664" b="80000" l="15261" r="74938">
                          <a14:foregroundMark x1="19231" y1="53832" x2="15261" y2="63551"/>
                          <a14:foregroundMark x1="15261" y1="63551" x2="18859" y2="75888"/>
                          <a14:foregroundMark x1="21464" y1="49533" x2="21464" y2="47664"/>
                          <a14:foregroundMark x1="68486" y1="74953" x2="74938" y2="74953"/>
                        </a14:backgroundRemoval>
                      </a14:imgEffect>
                    </a14:imgLayer>
                  </a14:imgProps>
                </a:ext>
              </a:extLst>
            </a:blip>
            <a:srcRect l="13238" t="44649" r="25317" b="16065"/>
            <a:stretch/>
          </p:blipFill>
          <p:spPr>
            <a:xfrm>
              <a:off x="3945035" y="5278371"/>
              <a:ext cx="771259" cy="359959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1B25B654-3130-6D49-041E-24A6F31EE7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ackgroundRemoval t="54393" b="83551" l="14020" r="71588">
                          <a14:foregroundMark x1="25062" y1="76822" x2="14020" y2="75327"/>
                          <a14:foregroundMark x1="64516" y1="54393" x2="69479" y2="57383"/>
                          <a14:foregroundMark x1="71340" y1="59813" x2="71712" y2="75514"/>
                          <a14:foregroundMark x1="53846" y1="82056" x2="41563" y2="83551"/>
                        </a14:backgroundRemoval>
                      </a14:imgEffect>
                    </a14:imgLayer>
                  </a14:imgProps>
                </a:ext>
              </a:extLst>
            </a:blip>
            <a:srcRect l="11937" t="51392" r="26714" b="13040"/>
            <a:stretch/>
          </p:blipFill>
          <p:spPr>
            <a:xfrm>
              <a:off x="3150370" y="5331734"/>
              <a:ext cx="769061" cy="330809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4E484416-8ECB-0212-2B3A-047CA79291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ackgroundRemoval t="36822" b="65421" l="23697" r="75931">
                          <a14:foregroundMark x1="29529" y1="54393" x2="23945" y2="53645"/>
                          <a14:foregroundMark x1="34491" y1="37009" x2="33747" y2="37009"/>
                          <a14:foregroundMark x1="75434" y1="56449" x2="75931" y2="56636"/>
                        </a14:backgroundRemoval>
                      </a14:imgEffect>
                    </a14:imgLayer>
                  </a14:imgProps>
                </a:ext>
              </a:extLst>
            </a:blip>
            <a:srcRect l="23705" t="33936" r="21428" b="30943"/>
            <a:stretch/>
          </p:blipFill>
          <p:spPr>
            <a:xfrm>
              <a:off x="3911429" y="4256437"/>
              <a:ext cx="754828" cy="323324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F38BA830-BBB5-B597-C613-BBE6C8CD7F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ackgroundRemoval t="42243" b="79065" l="10174" r="76799">
                          <a14:foregroundMark x1="14144" y1="63551" x2="13524" y2="60935"/>
                          <a14:foregroundMark x1="12159" y1="57944" x2="10174" y2="58131"/>
                          <a14:foregroundMark x1="73201" y1="47850" x2="73945" y2="42804"/>
                          <a14:foregroundMark x1="73945" y1="45421" x2="76923" y2="56636"/>
                          <a14:foregroundMark x1="62159" y1="77383" x2="68859" y2="79065"/>
                        </a14:backgroundRemoval>
                      </a14:imgEffect>
                    </a14:imgLayer>
                  </a14:imgProps>
                </a:ext>
              </a:extLst>
            </a:blip>
            <a:srcRect l="8929" t="37727" r="19345" b="16893"/>
            <a:stretch/>
          </p:blipFill>
          <p:spPr>
            <a:xfrm>
              <a:off x="3104629" y="4202930"/>
              <a:ext cx="819432" cy="368386"/>
            </a:xfrm>
            <a:prstGeom prst="rect">
              <a:avLst/>
            </a:prstGeom>
          </p:spPr>
        </p:pic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7B754125-AF0E-9511-4569-4C30B277EBC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ackgroundRemoval t="42243" b="99813" l="1241" r="95658">
                        <a14:foregroundMark x1="14144" y1="63551" x2="13524" y2="60935"/>
                        <a14:foregroundMark x1="12159" y1="57944" x2="10174" y2="58131"/>
                        <a14:foregroundMark x1="73201" y1="47850" x2="73945" y2="42804"/>
                        <a14:foregroundMark x1="73945" y1="45421" x2="76923" y2="56636"/>
                        <a14:foregroundMark x1="62159" y1="77383" x2="68859" y2="79065"/>
                        <a14:foregroundMark x1="4218" y1="92897" x2="23573" y2="94206"/>
                        <a14:foregroundMark x1="2730" y1="91402" x2="7072" y2="96822"/>
                        <a14:foregroundMark x1="1241" y1="95140" x2="17246" y2="92523"/>
                        <a14:foregroundMark x1="12407" y1="96075" x2="17246" y2="93645"/>
                        <a14:foregroundMark x1="26179" y1="92523" x2="11538" y2="91402"/>
                        <a14:foregroundMark x1="18114" y1="89720" x2="5583" y2="91589"/>
                        <a14:foregroundMark x1="5955" y1="91776" x2="11414" y2="90654"/>
                        <a14:foregroundMark x1="7444" y1="89720" x2="15136" y2="93084"/>
                        <a14:foregroundMark x1="15136" y1="93084" x2="15261" y2="93084"/>
                        <a14:foregroundMark x1="6452" y1="86729" x2="18610" y2="86355"/>
                        <a14:foregroundMark x1="18610" y1="86355" x2="26303" y2="86355"/>
                        <a14:foregroundMark x1="41315" y1="88598" x2="59677" y2="86729"/>
                        <a14:foregroundMark x1="22457" y1="88224" x2="45533" y2="87290"/>
                        <a14:foregroundMark x1="72654" y1="92593" x2="79777" y2="94953"/>
                        <a14:foregroundMark x1="71385" y1="92173" x2="71873" y2="92335"/>
                        <a14:foregroundMark x1="56079" y1="87103" x2="68499" y2="91217"/>
                        <a14:foregroundMark x1="64516" y1="87477" x2="67244" y2="88248"/>
                        <a14:foregroundMark x1="74403" y1="88840" x2="86973" y2="91776"/>
                        <a14:foregroundMark x1="39330" y1="94953" x2="78412" y2="96262"/>
                        <a14:foregroundMark x1="26055" y1="86729" x2="50124" y2="85421"/>
                        <a14:foregroundMark x1="50124" y1="85421" x2="58933" y2="88037"/>
                        <a14:foregroundMark x1="58933" y1="88037" x2="66501" y2="87477"/>
                        <a14:foregroundMark x1="66501" y1="87477" x2="66625" y2="87477"/>
                        <a14:foregroundMark x1="73588" y1="85624" x2="87469" y2="85981"/>
                        <a14:foregroundMark x1="71106" y1="85560" x2="72065" y2="85585"/>
                        <a14:foregroundMark x1="69365" y1="85515" x2="70952" y2="85556"/>
                        <a14:foregroundMark x1="58437" y1="85234" x2="67662" y2="85471"/>
                        <a14:foregroundMark x1="87469" y1="85981" x2="91191" y2="87477"/>
                        <a14:foregroundMark x1="90819" y1="87850" x2="95037" y2="99065"/>
                        <a14:foregroundMark x1="95037" y1="99065" x2="95658" y2="99813"/>
                        <a14:foregroundMark x1="89950" y1="96449" x2="89950" y2="96449"/>
                        <a14:backgroundMark x1="93424" y1="88224" x2="93424" y2="88224"/>
                        <a14:backgroundMark x1="94789" y1="89533" x2="94789" y2="89533"/>
                        <a14:backgroundMark x1="72829" y1="89720" x2="70454" y2="90166"/>
                        <a14:backgroundMark x1="70347" y1="89720" x2="67866" y2="89720"/>
                        <a14:backgroundMark x1="70347" y1="87477" x2="68362" y2="88224"/>
                        <a14:backgroundMark x1="70347" y1="87664" x2="68983" y2="87664"/>
                        <a14:backgroundMark x1="71836" y1="87664" x2="71836" y2="87664"/>
                        <a14:backgroundMark x1="72208" y1="88972" x2="72457" y2="90093"/>
                        <a14:backgroundMark x1="72208" y1="89533" x2="71340" y2="87103"/>
                        <a14:backgroundMark x1="72208" y1="88037" x2="72208" y2="88037"/>
                        <a14:backgroundMark x1="72457" y1="88037" x2="72457" y2="88037"/>
                        <a14:backgroundMark x1="72457" y1="88598" x2="72457" y2="88598"/>
                        <a14:backgroundMark x1="71588" y1="88037" x2="71588" y2="88037"/>
                        <a14:backgroundMark x1="72084" y1="87664" x2="72084" y2="87664"/>
                        <a14:backgroundMark x1="72084" y1="88411" x2="72084" y2="88411"/>
                        <a14:backgroundMark x1="72084" y1="88037" x2="72084" y2="88037"/>
                        <a14:backgroundMark x1="71340" y1="87103" x2="71340" y2="87103"/>
                        <a14:backgroundMark x1="71340" y1="87103" x2="72705" y2="87477"/>
                        <a14:backgroundMark x1="70968" y1="88411" x2="70968" y2="88411"/>
                        <a14:backgroundMark x1="72084" y1="88785" x2="72084" y2="88785"/>
                        <a14:backgroundMark x1="72457" y1="88598" x2="72457" y2="88598"/>
                      </a14:backgroundRemoval>
                    </a14:imgEffect>
                  </a14:imgLayer>
                </a14:imgProps>
              </a:ext>
            </a:extLst>
          </a:blip>
          <a:srcRect l="69470" t="85824" r="5642" b="1686"/>
          <a:stretch/>
        </p:blipFill>
        <p:spPr>
          <a:xfrm>
            <a:off x="848274" y="2809881"/>
            <a:ext cx="336478" cy="12529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9CA59DF-BD11-C421-FA54-1DD23677D9A3}"/>
              </a:ext>
            </a:extLst>
          </p:cNvPr>
          <p:cNvSpPr txBox="1"/>
          <p:nvPr/>
        </p:nvSpPr>
        <p:spPr>
          <a:xfrm>
            <a:off x="198825" y="2899030"/>
            <a:ext cx="9460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1139.58 m/z ±15 ppm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BE37DE0-0EA3-BE8D-6584-B1E740112D54}"/>
              </a:ext>
            </a:extLst>
          </p:cNvPr>
          <p:cNvSpPr/>
          <p:nvPr/>
        </p:nvSpPr>
        <p:spPr>
          <a:xfrm>
            <a:off x="373126" y="1710165"/>
            <a:ext cx="1329209" cy="2215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4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1A1 - </a:t>
            </a:r>
            <a:r>
              <a:rPr lang="en-US" sz="84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GRTGD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C797C26-FD6A-239C-B35C-E261959173C4}"/>
              </a:ext>
            </a:extLst>
          </p:cNvPr>
          <p:cNvGrpSpPr/>
          <p:nvPr/>
        </p:nvGrpSpPr>
        <p:grpSpPr>
          <a:xfrm>
            <a:off x="51400" y="2836492"/>
            <a:ext cx="358721" cy="182981"/>
            <a:chOff x="-148997" y="7157054"/>
            <a:chExt cx="1550323" cy="504427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BC6169A-A49D-80B4-7A4B-F7F0DD92B97C}"/>
                </a:ext>
              </a:extLst>
            </p:cNvPr>
            <p:cNvGrpSpPr/>
            <p:nvPr/>
          </p:nvGrpSpPr>
          <p:grpSpPr>
            <a:xfrm>
              <a:off x="416356" y="7202058"/>
              <a:ext cx="427648" cy="75910"/>
              <a:chOff x="409784" y="7202058"/>
              <a:chExt cx="427648" cy="75910"/>
            </a:xfrm>
          </p:grpSpPr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A6C5CE0F-9ACF-C368-11FA-4E024532DA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784" y="7240013"/>
                <a:ext cx="427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01930087-3D9B-C5A0-47BA-A0B138B5402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09784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E680400D-53A7-C4F0-E7D1-369F0B97A4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7432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089922E-D158-60B0-41FA-E468D64448BA}"/>
                </a:ext>
              </a:extLst>
            </p:cNvPr>
            <p:cNvSpPr txBox="1"/>
            <p:nvPr/>
          </p:nvSpPr>
          <p:spPr>
            <a:xfrm>
              <a:off x="-148997" y="7157054"/>
              <a:ext cx="1550323" cy="5044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1 cm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35A4E783-529A-3E5E-3999-EDD8DC007ACC}"/>
              </a:ext>
            </a:extLst>
          </p:cNvPr>
          <p:cNvSpPr txBox="1"/>
          <p:nvPr/>
        </p:nvSpPr>
        <p:spPr>
          <a:xfrm>
            <a:off x="1192097" y="1840260"/>
            <a:ext cx="604587" cy="270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78" b="1" dirty="0">
                <a:latin typeface="Arial" panose="020B0604020202020204" pitchFamily="34" charset="0"/>
                <a:cs typeface="Arial" panose="020B0604020202020204" pitchFamily="34" charset="0"/>
              </a:rPr>
              <a:t>Col1A1 1139.58 m/z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EE6F0D-9D80-056A-A85A-37CDCBEB2AFF}"/>
              </a:ext>
            </a:extLst>
          </p:cNvPr>
          <p:cNvSpPr txBox="1"/>
          <p:nvPr/>
        </p:nvSpPr>
        <p:spPr>
          <a:xfrm>
            <a:off x="1775959" y="2422755"/>
            <a:ext cx="4464629" cy="3347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26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QGPSGASGPAGPRGPPGSAGAPGKDGLN</a:t>
            </a:r>
            <a:r>
              <a:rPr lang="en-US" sz="525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GRTGD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PVGPPGPPGPPGPPGPPSAGFDFSFLPQPPQEKAHDGGRYYRA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18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…P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26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QGPSGASGPAGPRGPPGSAGAPGKDGLN</a:t>
            </a:r>
            <a:r>
              <a:rPr lang="en-US" sz="525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GRTGD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PVGPPGPPGPPGPPGPPSAGFDFSFLPQPPQEKAHDGGRYYRA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18</a:t>
            </a:r>
            <a:b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H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38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DQGAPGSVGPAGPRGPAGPSGPAGKDGRTGIRGPQGHQGPAGPPGPPGPPGPPGVSGGGYDFGYDGDFYRADQPRSAPSLRP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30 </a:t>
            </a:r>
            <a:endParaRPr lang="en-US" sz="126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E3C14B3-268F-A98F-715B-3CEFE1D4E462}"/>
              </a:ext>
            </a:extLst>
          </p:cNvPr>
          <p:cNvSpPr txBox="1"/>
          <p:nvPr/>
        </p:nvSpPr>
        <p:spPr>
          <a:xfrm>
            <a:off x="6089741" y="2435679"/>
            <a:ext cx="269626" cy="1812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78" b="1" dirty="0">
                <a:latin typeface="Arial" panose="020B0604020202020204" pitchFamily="34" charset="0"/>
                <a:cs typeface="Arial" panose="020B0604020202020204" pitchFamily="34" charset="0"/>
              </a:rPr>
              <a:t>⍺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FD21A6A-A98D-8AFD-56BD-6B33E384F1D1}"/>
              </a:ext>
            </a:extLst>
          </p:cNvPr>
          <p:cNvSpPr txBox="1"/>
          <p:nvPr/>
        </p:nvSpPr>
        <p:spPr>
          <a:xfrm>
            <a:off x="6091617" y="2559552"/>
            <a:ext cx="269626" cy="1812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78" b="1" dirty="0">
                <a:latin typeface="Arial" panose="020B0604020202020204" pitchFamily="34" charset="0"/>
                <a:cs typeface="Arial" panose="020B0604020202020204" pitchFamily="34" charset="0"/>
              </a:rPr>
              <a:t>⍺2</a:t>
            </a:r>
          </a:p>
        </p:txBody>
      </p:sp>
      <p:sp>
        <p:nvSpPr>
          <p:cNvPr id="35" name="Right Bracket 34">
            <a:extLst>
              <a:ext uri="{FF2B5EF4-FFF2-40B4-BE49-F238E27FC236}">
                <a16:creationId xmlns:a16="http://schemas.microsoft.com/office/drawing/2014/main" id="{0903BB80-B8F0-9C09-42D0-A1D8A29CDB3F}"/>
              </a:ext>
            </a:extLst>
          </p:cNvPr>
          <p:cNvSpPr/>
          <p:nvPr/>
        </p:nvSpPr>
        <p:spPr>
          <a:xfrm>
            <a:off x="6107116" y="2487074"/>
            <a:ext cx="24002" cy="78093"/>
          </a:xfrm>
          <a:prstGeom prst="righ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45"/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E1D136F9-AEAF-1492-43E5-1A3DF93B7B52}"/>
              </a:ext>
            </a:extLst>
          </p:cNvPr>
          <p:cNvCxnSpPr/>
          <p:nvPr/>
        </p:nvCxnSpPr>
        <p:spPr>
          <a:xfrm>
            <a:off x="6103541" y="2655015"/>
            <a:ext cx="631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ECE33AC2-B0B7-CC2B-F782-58B111466EA0}"/>
              </a:ext>
            </a:extLst>
          </p:cNvPr>
          <p:cNvSpPr/>
          <p:nvPr/>
        </p:nvSpPr>
        <p:spPr>
          <a:xfrm>
            <a:off x="1915119" y="2302208"/>
            <a:ext cx="4039064" cy="137345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85000"/>
                  <a:alpha val="5238"/>
                </a:schemeClr>
              </a:gs>
              <a:gs pos="50000">
                <a:schemeClr val="bg2">
                  <a:lumMod val="90000"/>
                </a:schemeClr>
              </a:gs>
              <a:gs pos="99000">
                <a:schemeClr val="bg2">
                  <a:lumMod val="75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3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yloid Precursor Protein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B0410A6-98C7-1C0B-1DB0-8B3F951F634D}"/>
              </a:ext>
            </a:extLst>
          </p:cNvPr>
          <p:cNvSpPr/>
          <p:nvPr/>
        </p:nvSpPr>
        <p:spPr>
          <a:xfrm>
            <a:off x="1915119" y="2146255"/>
            <a:ext cx="3391162" cy="137345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85000"/>
                  <a:alpha val="7235"/>
                </a:schemeClr>
              </a:gs>
              <a:gs pos="50000">
                <a:schemeClr val="bg2">
                  <a:lumMod val="90000"/>
                </a:schemeClr>
              </a:gs>
              <a:gs pos="98000">
                <a:schemeClr val="bg2">
                  <a:lumMod val="75000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3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leukin 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683285B-40C3-5046-7883-55DD1CFA266C}"/>
              </a:ext>
            </a:extLst>
          </p:cNvPr>
          <p:cNvSpPr txBox="1"/>
          <p:nvPr/>
        </p:nvSpPr>
        <p:spPr>
          <a:xfrm>
            <a:off x="4905810" y="1971663"/>
            <a:ext cx="1380804" cy="1892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30" dirty="0">
                <a:solidFill>
                  <a:srgbClr val="211E1E"/>
                </a:solidFill>
                <a:latin typeface="ArialNarrow" panose="020B0604020202020204" pitchFamily="34" charset="0"/>
              </a:rPr>
              <a:t>C-Proteinase cleavage site </a:t>
            </a:r>
            <a:endParaRPr lang="en-US" sz="630" dirty="0"/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64599B0-1EEB-005D-8613-9F364CDE6F21}"/>
              </a:ext>
            </a:extLst>
          </p:cNvPr>
          <p:cNvCxnSpPr>
            <a:cxnSpLocks/>
          </p:cNvCxnSpPr>
          <p:nvPr/>
        </p:nvCxnSpPr>
        <p:spPr>
          <a:xfrm>
            <a:off x="5310994" y="2096271"/>
            <a:ext cx="0" cy="668896"/>
          </a:xfrm>
          <a:prstGeom prst="line">
            <a:avLst/>
          </a:prstGeom>
          <a:ln w="9525">
            <a:solidFill>
              <a:srgbClr val="FF0000"/>
            </a:solidFill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E6AA07E0-9894-3A8D-E68B-FD3257E21309}"/>
              </a:ext>
            </a:extLst>
          </p:cNvPr>
          <p:cNvSpPr/>
          <p:nvPr/>
        </p:nvSpPr>
        <p:spPr>
          <a:xfrm>
            <a:off x="5308408" y="2147977"/>
            <a:ext cx="645774" cy="135623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590" b="1" baseline="30000" dirty="0">
                <a:solidFill>
                  <a:schemeClr val="bg1"/>
                </a:solidFill>
                <a:latin typeface="ArialNarrow" panose="020B0604020202020204" pitchFamily="34" charset="0"/>
              </a:rPr>
              <a:t>2</a:t>
            </a:r>
            <a:r>
              <a:rPr lang="en-US" sz="590" b="1" dirty="0">
                <a:solidFill>
                  <a:schemeClr val="bg1"/>
                </a:solidFill>
                <a:latin typeface="ArialNarrow" panose="020B0604020202020204" pitchFamily="34" charset="0"/>
              </a:rPr>
              <a:t>C-Pep. Domain</a:t>
            </a:r>
            <a:endParaRPr lang="en-US" sz="590" b="1" dirty="0">
              <a:solidFill>
                <a:schemeClr val="bg1"/>
              </a:solidFill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7B30EDD-8E48-99B1-D6E2-330F24B06223}"/>
              </a:ext>
            </a:extLst>
          </p:cNvPr>
          <p:cNvSpPr/>
          <p:nvPr/>
        </p:nvSpPr>
        <p:spPr>
          <a:xfrm>
            <a:off x="3278454" y="1990302"/>
            <a:ext cx="372358" cy="148201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A9C6A3F-35C8-BDEF-F477-50CE68442837}"/>
              </a:ext>
            </a:extLst>
          </p:cNvPr>
          <p:cNvSpPr txBox="1"/>
          <p:nvPr/>
        </p:nvSpPr>
        <p:spPr>
          <a:xfrm>
            <a:off x="104035" y="4643496"/>
            <a:ext cx="6049863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5: Collagen Fibril binding partners for peptide sequences upregulated in medial human Osteoarthriti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The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OL1A1 peptide G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165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RGRTGD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17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t m/z 1139.58 exists in a region of the mature collagen fibril with multiple binding partners including, Amyloid Precursor Protein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nterlueki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2, and Phosphophoryn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) Another COL1A1 peptide upregulated in medial OA tissues, </a:t>
            </a:r>
            <a:r>
              <a:rPr lang="en-US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</a:t>
            </a:r>
            <a:r>
              <a:rPr lang="en-US" sz="1200" kern="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26</a:t>
            </a:r>
            <a:r>
              <a:rPr lang="en-US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GERGEQ</a:t>
            </a:r>
            <a:r>
              <a:rPr lang="en-US" sz="1200" kern="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34</a:t>
            </a:r>
            <a:r>
              <a:rPr lang="en-US" sz="1200" kern="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200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overlaps a known glycation site and a proposed region fo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eratan sulfate interaction.  Protein sequences of the mature Collagen 1 triple helix are show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sGenBankT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⍺1(I) accession #NP000079.2 and ⍺2(I) NP_000080.2. Amino Acid positions noted are from UniProt P02452 CO1A1_HUMAN and P08123 CO1A2_HUMAN. Collagen fibril binding zones schematics adapted from “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onio, J. D. S.,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cenko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O.,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rtal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. &amp; Orgel, J. P. R. O. Collagen Structure-Function Mapping Informs Applications for Regenerative Medicine. </a:t>
            </a:r>
            <a:r>
              <a:rPr 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eng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3 (2020)”.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HOS: </a:t>
            </a:r>
            <a:r>
              <a:rPr lang="en-US" sz="1200" dirty="0">
                <a:solidFill>
                  <a:srgbClr val="211E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phoryn binding site. </a:t>
            </a:r>
            <a:r>
              <a:rPr lang="en-US" sz="1200" baseline="30000" dirty="0">
                <a:solidFill>
                  <a:srgbClr val="211E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-Pep. Domain - C-telopeptid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ibrillogenesi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nucleation domain. </a:t>
            </a:r>
            <a:r>
              <a:rPr lang="en-US" sz="1200" baseline="30000" dirty="0">
                <a:solidFill>
                  <a:srgbClr val="211E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211E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PG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SPG - Proposed sites of keratan sulfate proteoglycan binding.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DCDFCEB-2F0F-228F-976E-FAAAFEC1A7A3}"/>
              </a:ext>
            </a:extLst>
          </p:cNvPr>
          <p:cNvSpPr txBox="1"/>
          <p:nvPr/>
        </p:nvSpPr>
        <p:spPr>
          <a:xfrm>
            <a:off x="1193087" y="3177174"/>
            <a:ext cx="602607" cy="270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78" b="1" dirty="0">
                <a:latin typeface="Arial" panose="020B0604020202020204" pitchFamily="34" charset="0"/>
                <a:cs typeface="Arial" panose="020B0604020202020204" pitchFamily="34" charset="0"/>
              </a:rPr>
              <a:t>Col1A1 900.40 m/z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11BEA68-22C4-AD6A-2980-91E4CB21D831}"/>
              </a:ext>
            </a:extLst>
          </p:cNvPr>
          <p:cNvSpPr txBox="1"/>
          <p:nvPr/>
        </p:nvSpPr>
        <p:spPr>
          <a:xfrm>
            <a:off x="251498" y="3053913"/>
            <a:ext cx="1572464" cy="2215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0" b="1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L1A1 - </a:t>
            </a:r>
            <a:r>
              <a:rPr lang="en-US" sz="840" b="1" kern="0" dirty="0">
                <a:solidFill>
                  <a:schemeClr val="accent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PAGERGEQ</a:t>
            </a:r>
            <a:r>
              <a:rPr lang="en-US" sz="84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E68C62A8-3104-2FCC-B59F-16EA0D4759C1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ackgroundRemoval t="42243" b="99813" l="1241" r="95658">
                        <a14:foregroundMark x1="14144" y1="63551" x2="13524" y2="60935"/>
                        <a14:foregroundMark x1="12159" y1="57944" x2="10174" y2="58131"/>
                        <a14:foregroundMark x1="73201" y1="47850" x2="73945" y2="42804"/>
                        <a14:foregroundMark x1="73945" y1="45421" x2="76923" y2="56636"/>
                        <a14:foregroundMark x1="62159" y1="77383" x2="68859" y2="79065"/>
                        <a14:foregroundMark x1="4218" y1="92897" x2="23573" y2="94206"/>
                        <a14:foregroundMark x1="2730" y1="91402" x2="7072" y2="96822"/>
                        <a14:foregroundMark x1="1241" y1="95140" x2="17246" y2="92523"/>
                        <a14:foregroundMark x1="12407" y1="96075" x2="17246" y2="93645"/>
                        <a14:foregroundMark x1="26179" y1="92523" x2="11538" y2="91402"/>
                        <a14:foregroundMark x1="18114" y1="89720" x2="5583" y2="91589"/>
                        <a14:foregroundMark x1="5955" y1="91776" x2="11414" y2="90654"/>
                        <a14:foregroundMark x1="7444" y1="89720" x2="15136" y2="93084"/>
                        <a14:foregroundMark x1="15136" y1="93084" x2="15261" y2="93084"/>
                        <a14:foregroundMark x1="6452" y1="86729" x2="18610" y2="86355"/>
                        <a14:foregroundMark x1="18610" y1="86355" x2="26303" y2="86355"/>
                        <a14:foregroundMark x1="41315" y1="88598" x2="59677" y2="86729"/>
                        <a14:foregroundMark x1="22457" y1="88224" x2="45533" y2="87290"/>
                        <a14:foregroundMark x1="72654" y1="92593" x2="79777" y2="94953"/>
                        <a14:foregroundMark x1="71385" y1="92173" x2="71873" y2="92335"/>
                        <a14:foregroundMark x1="56079" y1="87103" x2="68499" y2="91217"/>
                        <a14:foregroundMark x1="64516" y1="87477" x2="67244" y2="88248"/>
                        <a14:foregroundMark x1="74403" y1="88840" x2="86973" y2="91776"/>
                        <a14:foregroundMark x1="39330" y1="94953" x2="78412" y2="96262"/>
                        <a14:foregroundMark x1="26055" y1="86729" x2="50124" y2="85421"/>
                        <a14:foregroundMark x1="50124" y1="85421" x2="58933" y2="88037"/>
                        <a14:foregroundMark x1="58933" y1="88037" x2="66501" y2="87477"/>
                        <a14:foregroundMark x1="66501" y1="87477" x2="66625" y2="87477"/>
                        <a14:foregroundMark x1="73588" y1="85624" x2="87469" y2="85981"/>
                        <a14:foregroundMark x1="71106" y1="85560" x2="72065" y2="85585"/>
                        <a14:foregroundMark x1="69365" y1="85515" x2="70952" y2="85556"/>
                        <a14:foregroundMark x1="58437" y1="85234" x2="67662" y2="85471"/>
                        <a14:foregroundMark x1="87469" y1="85981" x2="91191" y2="87477"/>
                        <a14:foregroundMark x1="90819" y1="87850" x2="95037" y2="99065"/>
                        <a14:foregroundMark x1="95037" y1="99065" x2="95658" y2="99813"/>
                        <a14:foregroundMark x1="89950" y1="96449" x2="89950" y2="96449"/>
                        <a14:backgroundMark x1="93424" y1="88224" x2="93424" y2="88224"/>
                        <a14:backgroundMark x1="94789" y1="89533" x2="94789" y2="89533"/>
                        <a14:backgroundMark x1="72829" y1="89720" x2="70454" y2="90166"/>
                        <a14:backgroundMark x1="70347" y1="89720" x2="67866" y2="89720"/>
                        <a14:backgroundMark x1="70347" y1="87477" x2="68362" y2="88224"/>
                        <a14:backgroundMark x1="70347" y1="87664" x2="68983" y2="87664"/>
                        <a14:backgroundMark x1="71836" y1="87664" x2="71836" y2="87664"/>
                        <a14:backgroundMark x1="72208" y1="88972" x2="72457" y2="90093"/>
                        <a14:backgroundMark x1="72208" y1="89533" x2="71340" y2="87103"/>
                        <a14:backgroundMark x1="72208" y1="88037" x2="72208" y2="88037"/>
                        <a14:backgroundMark x1="72457" y1="88037" x2="72457" y2="88037"/>
                        <a14:backgroundMark x1="72457" y1="88598" x2="72457" y2="88598"/>
                        <a14:backgroundMark x1="71588" y1="88037" x2="71588" y2="88037"/>
                        <a14:backgroundMark x1="72084" y1="87664" x2="72084" y2="87664"/>
                        <a14:backgroundMark x1="72084" y1="88411" x2="72084" y2="88411"/>
                        <a14:backgroundMark x1="72084" y1="88037" x2="72084" y2="88037"/>
                        <a14:backgroundMark x1="71340" y1="87103" x2="71340" y2="87103"/>
                        <a14:backgroundMark x1="71340" y1="87103" x2="72705" y2="87477"/>
                        <a14:backgroundMark x1="70968" y1="88411" x2="70968" y2="88411"/>
                        <a14:backgroundMark x1="72084" y1="88785" x2="72084" y2="88785"/>
                        <a14:backgroundMark x1="72457" y1="88598" x2="72457" y2="88598"/>
                      </a14:backgroundRemoval>
                    </a14:imgEffect>
                  </a14:imgLayer>
                </a14:imgProps>
              </a:ext>
            </a:extLst>
          </a:blip>
          <a:srcRect l="69470" t="85824" r="5642" b="1686"/>
          <a:stretch/>
        </p:blipFill>
        <p:spPr>
          <a:xfrm>
            <a:off x="830211" y="4148776"/>
            <a:ext cx="331935" cy="125356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700A9F84-6F4D-2F74-E02F-B4067876ABF3}"/>
              </a:ext>
            </a:extLst>
          </p:cNvPr>
          <p:cNvSpPr txBox="1"/>
          <p:nvPr/>
        </p:nvSpPr>
        <p:spPr>
          <a:xfrm>
            <a:off x="221412" y="4240531"/>
            <a:ext cx="9028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900.40 m/z ±15 ppm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73020EDD-A65B-3C16-740F-D1E81822447F}"/>
              </a:ext>
            </a:extLst>
          </p:cNvPr>
          <p:cNvGrpSpPr/>
          <p:nvPr/>
        </p:nvGrpSpPr>
        <p:grpSpPr>
          <a:xfrm>
            <a:off x="37612" y="4183889"/>
            <a:ext cx="487106" cy="182981"/>
            <a:chOff x="-124950" y="7138748"/>
            <a:chExt cx="2133989" cy="504163"/>
          </a:xfrm>
        </p:grpSpPr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9C6C12ED-5675-2C90-BE20-9EBFB110D397}"/>
                </a:ext>
              </a:extLst>
            </p:cNvPr>
            <p:cNvGrpSpPr/>
            <p:nvPr/>
          </p:nvGrpSpPr>
          <p:grpSpPr>
            <a:xfrm>
              <a:off x="416356" y="7202058"/>
              <a:ext cx="427648" cy="75910"/>
              <a:chOff x="409784" y="7202058"/>
              <a:chExt cx="427648" cy="75910"/>
            </a:xfrm>
          </p:grpSpPr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09EAE080-23D9-92F2-F53E-ABC5EC6574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784" y="7240013"/>
                <a:ext cx="42764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03B2CE3A-7A54-96D3-4F26-C086A05DBED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09784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87F1A595-D579-8343-56D8-55BCB20C44C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7432" y="7202058"/>
                <a:ext cx="0" cy="759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E92DFBD-F198-03E2-D700-9B2B0615E9D1}"/>
                </a:ext>
              </a:extLst>
            </p:cNvPr>
            <p:cNvSpPr txBox="1"/>
            <p:nvPr/>
          </p:nvSpPr>
          <p:spPr>
            <a:xfrm>
              <a:off x="-124950" y="7138748"/>
              <a:ext cx="2133989" cy="504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1 cm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70CF68CD-B9B5-E087-4D1F-6C296C0B9AF5}"/>
              </a:ext>
            </a:extLst>
          </p:cNvPr>
          <p:cNvGrpSpPr/>
          <p:nvPr/>
        </p:nvGrpSpPr>
        <p:grpSpPr>
          <a:xfrm>
            <a:off x="99721" y="3223936"/>
            <a:ext cx="1012005" cy="921085"/>
            <a:chOff x="7208149" y="1342430"/>
            <a:chExt cx="4393546" cy="3871449"/>
          </a:xfrm>
        </p:grpSpPr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C074DF1B-5F06-AEED-CB25-5812E7E9D8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ackgroundRemoval t="24908" b="76015" l="15582" r="94344">
                          <a14:foregroundMark x1="19424" y1="64945" x2="18677" y2="31550"/>
                          <a14:foregroundMark x1="15688" y1="38376" x2="15688" y2="51292"/>
                          <a14:foregroundMark x1="24760" y1="28413" x2="34045" y2="25092"/>
                          <a14:foregroundMark x1="82924" y1="64022" x2="82711" y2="73247"/>
                          <a14:foregroundMark x1="81110" y1="69926" x2="94344" y2="69926"/>
                          <a14:foregroundMark x1="51441" y1="76015" x2="81323" y2="66790"/>
                          <a14:foregroundMark x1="81323" y1="66790" x2="63607" y2="74539"/>
                        </a14:backgroundRemoval>
                      </a14:imgEffect>
                    </a14:imgLayer>
                  </a14:imgProps>
                </a:ext>
              </a:extLst>
            </a:blip>
            <a:srcRect l="12440" t="22192" r="7358" b="19332"/>
            <a:stretch/>
          </p:blipFill>
          <p:spPr>
            <a:xfrm>
              <a:off x="9413097" y="3352104"/>
              <a:ext cx="2188598" cy="1011387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5FF82877-1932-4D29-B7D6-864585EB44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ackgroundRemoval t="16790" b="65314" l="12914" r="84952">
                          <a14:foregroundMark x1="24120" y1="37823" x2="18783" y2="53875"/>
                          <a14:foregroundMark x1="18036" y1="42435" x2="13020" y2="43727"/>
                          <a14:foregroundMark x1="19637" y1="64760" x2="32337" y2="61070"/>
                          <a14:foregroundMark x1="32337" y1="61070" x2="55496" y2="65498"/>
                          <a14:foregroundMark x1="55496" y1="65498" x2="73319" y2="59779"/>
                          <a14:foregroundMark x1="73319" y1="59779" x2="75454" y2="60148"/>
                          <a14:foregroundMark x1="78869" y1="53321" x2="78869" y2="53321"/>
                          <a14:foregroundMark x1="80683" y1="64760" x2="80683" y2="22694"/>
                          <a14:foregroundMark x1="83351" y1="28229" x2="84952" y2="28598"/>
                        </a14:backgroundRemoval>
                      </a14:imgEffect>
                    </a14:imgLayer>
                  </a14:imgProps>
                </a:ext>
              </a:extLst>
            </a:blip>
            <a:srcRect l="11117" t="11354" r="11647" b="32945"/>
            <a:stretch/>
          </p:blipFill>
          <p:spPr>
            <a:xfrm>
              <a:off x="7208149" y="1342430"/>
              <a:ext cx="2260852" cy="1008401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3852B961-FDDE-876E-0C83-537BF339D7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ackgroundRemoval t="22325" b="66421" l="24120" r="85592">
                          <a14:foregroundMark x1="24226" y1="62177" x2="24226" y2="32841"/>
                          <a14:foregroundMark x1="85592" y1="53875" x2="85379" y2="50185"/>
                        </a14:backgroundRemoval>
                      </a14:imgEffect>
                    </a14:imgLayer>
                  </a14:imgProps>
                </a:ext>
              </a:extLst>
            </a:blip>
            <a:srcRect l="19719" t="17160" r="9397" b="28026"/>
            <a:stretch/>
          </p:blipFill>
          <p:spPr>
            <a:xfrm>
              <a:off x="9315129" y="1504538"/>
              <a:ext cx="2179045" cy="937707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33630DED-52D0-C63E-F373-89D1C84661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ackgroundRemoval t="22694" b="73616" l="15902" r="84418">
                          <a14:foregroundMark x1="26254" y1="23247" x2="19424" y2="44096"/>
                          <a14:foregroundMark x1="19424" y1="44096" x2="20704" y2="61255"/>
                          <a14:foregroundMark x1="18036" y1="62546" x2="15902" y2="33395"/>
                          <a14:foregroundMark x1="82604" y1="58487" x2="84525" y2="61255"/>
                          <a14:foregroundMark x1="59125" y1="71771" x2="43436" y2="73616"/>
                        </a14:backgroundRemoval>
                      </a14:imgEffect>
                    </a14:imgLayer>
                  </a14:imgProps>
                </a:ext>
              </a:extLst>
            </a:blip>
            <a:srcRect l="13552" t="17158" r="10997" b="24366"/>
            <a:stretch/>
          </p:blipFill>
          <p:spPr>
            <a:xfrm>
              <a:off x="9343308" y="2358830"/>
              <a:ext cx="2135629" cy="1068696"/>
            </a:xfrm>
            <a:prstGeom prst="rect">
              <a:avLst/>
            </a:prstGeom>
          </p:spPr>
        </p:pic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1005B1E8-582E-2495-5284-852E88FBD5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ackgroundRemoval t="21587" b="77491" l="12487" r="83031">
                          <a14:foregroundMark x1="12593" y1="67528" x2="15795" y2="50554"/>
                          <a14:foregroundMark x1="83031" y1="65683" x2="79082" y2="42620"/>
                          <a14:foregroundMark x1="79082" y1="42620" x2="72252" y2="23616"/>
                          <a14:foregroundMark x1="72252" y1="23616" x2="71078" y2="23616"/>
                          <a14:foregroundMark x1="70864" y1="23063" x2="76414" y2="21771"/>
                          <a14:foregroundMark x1="42263" y1="73432" x2="47492" y2="73985"/>
                          <a14:foregroundMark x1="47492" y1="74354" x2="41942" y2="77491"/>
                        </a14:backgroundRemoval>
                      </a14:imgEffect>
                    </a14:imgLayer>
                  </a14:imgProps>
                </a:ext>
              </a:extLst>
            </a:blip>
            <a:srcRect l="8900" t="16747" r="12274" b="17265"/>
            <a:stretch/>
          </p:blipFill>
          <p:spPr>
            <a:xfrm>
              <a:off x="7391082" y="2384424"/>
              <a:ext cx="1995220" cy="1068697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DED5C82E-F59D-8DB6-4056-43896CE30F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ackgroundRemoval t="38561" b="77122" l="12166" r="79402">
                          <a14:foregroundMark x1="12273" y1="67528" x2="16009" y2="59594"/>
                          <a14:foregroundMark x1="71078" y1="75277" x2="76201" y2="52952"/>
                          <a14:foregroundMark x1="76201" y1="52952" x2="76414" y2="44649"/>
                          <a14:foregroundMark x1="78442" y1="71956" x2="79402" y2="49631"/>
                          <a14:foregroundMark x1="79402" y1="49631" x2="77908" y2="38561"/>
                        </a14:backgroundRemoval>
                      </a14:imgEffect>
                    </a14:imgLayer>
                  </a14:imgProps>
                </a:ext>
              </a:extLst>
            </a:blip>
            <a:srcRect l="7279" t="33765" r="15484" b="17731"/>
            <a:stretch/>
          </p:blipFill>
          <p:spPr>
            <a:xfrm>
              <a:off x="7354259" y="3502342"/>
              <a:ext cx="2114742" cy="813053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594289D7-571C-4166-8C19-A1900D3449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ackgroundRemoval t="18635" b="66421" l="16009" r="85592">
                          <a14:foregroundMark x1="19424" y1="54244" x2="19210" y2="34133"/>
                          <a14:foregroundMark x1="16009" y1="63469" x2="17076" y2="26753"/>
                          <a14:foregroundMark x1="53575" y1="66605" x2="29989" y2="64760"/>
                          <a14:foregroundMark x1="82711" y1="57011" x2="85059" y2="57011"/>
                          <a14:foregroundMark x1="27428" y1="18635" x2="23906" y2="18635"/>
                          <a14:foregroundMark x1="84312" y1="53875" x2="85592" y2="51107"/>
                        </a14:backgroundRemoval>
                      </a14:imgEffect>
                    </a14:imgLayer>
                  </a14:imgProps>
                </a:ext>
              </a:extLst>
            </a:blip>
            <a:srcRect l="14301" t="13286" r="10246" b="28238"/>
            <a:stretch/>
          </p:blipFill>
          <p:spPr>
            <a:xfrm>
              <a:off x="9476130" y="4204963"/>
              <a:ext cx="2014885" cy="965810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8F42B7AB-6D42-C2E2-0B8E-18DC7DE4A3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ackgroundRemoval t="38192" b="78598" l="5550" r="78549">
                          <a14:foregroundMark x1="10032" y1="67712" x2="13767" y2="57565"/>
                          <a14:foregroundMark x1="7684" y1="68081" x2="5763" y2="69004"/>
                          <a14:foregroundMark x1="56884" y1="74539" x2="44504" y2="74908"/>
                          <a14:foregroundMark x1="48986" y1="75461" x2="47065" y2="78598"/>
                          <a14:foregroundMark x1="77801" y1="69926" x2="78549" y2="69926"/>
                        </a14:backgroundRemoval>
                      </a14:imgEffect>
                    </a14:imgLayer>
                  </a14:imgProps>
                </a:ext>
              </a:extLst>
            </a:blip>
            <a:srcRect l="5543" t="33571" r="17221" b="19239"/>
            <a:stretch/>
          </p:blipFill>
          <p:spPr>
            <a:xfrm>
              <a:off x="7356587" y="4380926"/>
              <a:ext cx="2029717" cy="832953"/>
            </a:xfrm>
            <a:prstGeom prst="rect">
              <a:avLst/>
            </a:prstGeom>
          </p:spPr>
        </p:pic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id="{B9ECDD2E-9BD6-D34F-5714-B96ADD7229B0}"/>
              </a:ext>
            </a:extLst>
          </p:cNvPr>
          <p:cNvSpPr txBox="1"/>
          <p:nvPr/>
        </p:nvSpPr>
        <p:spPr>
          <a:xfrm>
            <a:off x="2059660" y="3510562"/>
            <a:ext cx="3157946" cy="3347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4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58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25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E</a:t>
            </a:r>
            <a:r>
              <a:rPr lang="en-US" sz="158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525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GEQ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SPGFQGLP</a:t>
            </a:r>
            <a:r>
              <a:rPr lang="en-US" sz="158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PPGEAGKPGEQGVPGDLGAPGPSGARGER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79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 </a:t>
            </a:r>
          </a:p>
          <a:p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4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58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25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E</a:t>
            </a:r>
            <a:r>
              <a:rPr lang="en-US" sz="158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525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GEQ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SPGFQGLP</a:t>
            </a:r>
            <a:r>
              <a:rPr lang="en-US" sz="158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AGPPGEAGKPGEQGVPGDLGAPGPSGARGER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79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 </a:t>
            </a:r>
          </a:p>
          <a:p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P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6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GVQGGKGEQGPAG</a:t>
            </a:r>
            <a:r>
              <a:rPr lang="en-US" sz="158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GFQGLPGPSGPAGEVGKPGERGLHGEFG</a:t>
            </a:r>
            <a:r>
              <a:rPr lang="en-US" sz="158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GPAG</a:t>
            </a:r>
            <a:r>
              <a:rPr lang="en-US" sz="158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GER</a:t>
            </a:r>
            <a:r>
              <a:rPr lang="en-US" sz="525" baseline="30000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91</a:t>
            </a:r>
            <a:r>
              <a:rPr lang="en-US" sz="525" dirty="0">
                <a:solidFill>
                  <a:srgbClr val="05070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…</a:t>
            </a:r>
            <a:endParaRPr lang="en-US" sz="525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BFD37B0-A26C-81B3-F72A-7C338CA639AF}"/>
              </a:ext>
            </a:extLst>
          </p:cNvPr>
          <p:cNvSpPr txBox="1"/>
          <p:nvPr/>
        </p:nvSpPr>
        <p:spPr>
          <a:xfrm>
            <a:off x="2445547" y="3891055"/>
            <a:ext cx="519694" cy="189283"/>
          </a:xfrm>
          <a:prstGeom prst="rect">
            <a:avLst/>
          </a:prstGeom>
          <a:noFill/>
          <a:ln w="3175">
            <a:noFill/>
          </a:ln>
        </p:spPr>
        <p:txBody>
          <a:bodyPr wrap="none" rtlCol="0">
            <a:spAutoFit/>
          </a:bodyPr>
          <a:lstStyle/>
          <a:p>
            <a:r>
              <a:rPr lang="en-US" sz="630" dirty="0">
                <a:latin typeface="Arial" panose="020B0604020202020204" pitchFamily="34" charset="0"/>
                <a:cs typeface="Arial" panose="020B0604020202020204" pitchFamily="34" charset="0"/>
              </a:rPr>
              <a:t>Glycation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43EED9D7-382D-C509-680D-93318B4FC256}"/>
              </a:ext>
            </a:extLst>
          </p:cNvPr>
          <p:cNvSpPr/>
          <p:nvPr/>
        </p:nvSpPr>
        <p:spPr>
          <a:xfrm>
            <a:off x="2632749" y="3483676"/>
            <a:ext cx="63154" cy="36018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45"/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5AA71384-0682-0205-45BE-8181A99E18A9}"/>
              </a:ext>
            </a:extLst>
          </p:cNvPr>
          <p:cNvCxnSpPr>
            <a:cxnSpLocks/>
            <a:stCxn id="81" idx="2"/>
          </p:cNvCxnSpPr>
          <p:nvPr/>
        </p:nvCxnSpPr>
        <p:spPr>
          <a:xfrm flipH="1">
            <a:off x="2661916" y="3843861"/>
            <a:ext cx="0" cy="7005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1CE070AC-44FE-C4FD-0C76-8181174ABFBA}"/>
              </a:ext>
            </a:extLst>
          </p:cNvPr>
          <p:cNvSpPr/>
          <p:nvPr/>
        </p:nvSpPr>
        <p:spPr>
          <a:xfrm>
            <a:off x="2546831" y="3412181"/>
            <a:ext cx="532837" cy="124476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55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5A021FA-5572-4CE6-62A3-7294A781F3AA}"/>
              </a:ext>
            </a:extLst>
          </p:cNvPr>
          <p:cNvSpPr/>
          <p:nvPr/>
        </p:nvSpPr>
        <p:spPr>
          <a:xfrm>
            <a:off x="4409030" y="3396587"/>
            <a:ext cx="1324573" cy="137345"/>
          </a:xfrm>
          <a:prstGeom prst="rect">
            <a:avLst/>
          </a:prstGeom>
          <a:gradFill flip="none" rotWithShape="1">
            <a:gsLst>
              <a:gs pos="0">
                <a:schemeClr val="bg2">
                  <a:lumMod val="75000"/>
                </a:schemeClr>
              </a:gs>
              <a:gs pos="50000">
                <a:schemeClr val="bg2"/>
              </a:gs>
              <a:gs pos="99000">
                <a:schemeClr val="bg1">
                  <a:lumMod val="85000"/>
                  <a:alpha val="22159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73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⍺1β1, ⍺2β1 integrin binding  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C299562B-09CB-DB49-6DCD-97360F39DBF9}"/>
              </a:ext>
            </a:extLst>
          </p:cNvPr>
          <p:cNvSpPr/>
          <p:nvPr/>
        </p:nvSpPr>
        <p:spPr>
          <a:xfrm>
            <a:off x="4256438" y="3804401"/>
            <a:ext cx="1382722" cy="137345"/>
          </a:xfrm>
          <a:prstGeom prst="rect">
            <a:avLst/>
          </a:prstGeom>
          <a:gradFill flip="none" rotWithShape="1">
            <a:gsLst>
              <a:gs pos="0">
                <a:schemeClr val="bg2">
                  <a:lumMod val="75000"/>
                </a:schemeClr>
              </a:gs>
              <a:gs pos="50000">
                <a:schemeClr val="bg2"/>
              </a:gs>
              <a:gs pos="99000">
                <a:schemeClr val="bg1">
                  <a:lumMod val="85000"/>
                  <a:alpha val="22159"/>
                </a:schemeClr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735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⍺1β1, ⍺2β1 integrin binding  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41E8DAB-A9D7-8BF9-2F4E-2433F153632C}"/>
              </a:ext>
            </a:extLst>
          </p:cNvPr>
          <p:cNvSpPr txBox="1"/>
          <p:nvPr/>
        </p:nvSpPr>
        <p:spPr>
          <a:xfrm>
            <a:off x="8823" y="1702086"/>
            <a:ext cx="292068" cy="2377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45" dirty="0"/>
              <a:t>A)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15DCE2F6-CECC-07B7-CE84-6859B199A625}"/>
              </a:ext>
            </a:extLst>
          </p:cNvPr>
          <p:cNvGrpSpPr/>
          <p:nvPr/>
        </p:nvGrpSpPr>
        <p:grpSpPr>
          <a:xfrm>
            <a:off x="1902057" y="1132119"/>
            <a:ext cx="4407167" cy="692651"/>
            <a:chOff x="3664749" y="189314"/>
            <a:chExt cx="8394603" cy="1319335"/>
          </a:xfrm>
        </p:grpSpPr>
        <p:pic>
          <p:nvPicPr>
            <p:cNvPr id="95" name="Picture 94" descr="A blue and yellow braided line&#10;&#10;Description automatically generated">
              <a:extLst>
                <a:ext uri="{FF2B5EF4-FFF2-40B4-BE49-F238E27FC236}">
                  <a16:creationId xmlns:a16="http://schemas.microsoft.com/office/drawing/2014/main" id="{58614FBB-D2EE-BEC2-8E45-1D0691F6BA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>
              <a:duotone>
                <a:prstClr val="black"/>
                <a:schemeClr val="tx2">
                  <a:tint val="45000"/>
                  <a:satMod val="400000"/>
                </a:schemeClr>
              </a:duotone>
            </a:blip>
            <a:srcRect t="36304" b="37392"/>
            <a:stretch/>
          </p:blipFill>
          <p:spPr>
            <a:xfrm rot="10800000">
              <a:off x="3798061" y="306013"/>
              <a:ext cx="7725860" cy="1202636"/>
            </a:xfrm>
            <a:prstGeom prst="rect">
              <a:avLst/>
            </a:prstGeom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82FF8C10-41AC-17E7-5ED9-8F03E7570406}"/>
                </a:ext>
              </a:extLst>
            </p:cNvPr>
            <p:cNvSpPr txBox="1"/>
            <p:nvPr/>
          </p:nvSpPr>
          <p:spPr>
            <a:xfrm>
              <a:off x="11545779" y="669640"/>
              <a:ext cx="513573" cy="345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78" b="1" dirty="0">
                  <a:latin typeface="Arial" panose="020B0604020202020204" pitchFamily="34" charset="0"/>
                  <a:cs typeface="Arial" panose="020B0604020202020204" pitchFamily="34" charset="0"/>
                </a:rPr>
                <a:t>⍺1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3689DB29-1886-D9BF-F79E-09FE95CB28F2}"/>
                </a:ext>
              </a:extLst>
            </p:cNvPr>
            <p:cNvSpPr txBox="1"/>
            <p:nvPr/>
          </p:nvSpPr>
          <p:spPr>
            <a:xfrm>
              <a:off x="11545779" y="880638"/>
              <a:ext cx="513573" cy="345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78" b="1" dirty="0">
                  <a:latin typeface="Arial" panose="020B0604020202020204" pitchFamily="34" charset="0"/>
                  <a:cs typeface="Arial" panose="020B0604020202020204" pitchFamily="34" charset="0"/>
                </a:rPr>
                <a:t>⍺2</a:t>
              </a:r>
            </a:p>
          </p:txBody>
        </p:sp>
        <p:sp>
          <p:nvSpPr>
            <p:cNvPr id="98" name="Right Bracket 97">
              <a:extLst>
                <a:ext uri="{FF2B5EF4-FFF2-40B4-BE49-F238E27FC236}">
                  <a16:creationId xmlns:a16="http://schemas.microsoft.com/office/drawing/2014/main" id="{3C9CC59B-D3BD-E75C-A626-A4E61860937F}"/>
                </a:ext>
              </a:extLst>
            </p:cNvPr>
            <p:cNvSpPr/>
            <p:nvPr/>
          </p:nvSpPr>
          <p:spPr>
            <a:xfrm>
              <a:off x="11590213" y="769749"/>
              <a:ext cx="45719" cy="148748"/>
            </a:xfrm>
            <a:prstGeom prst="righ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45"/>
            </a:p>
          </p:txBody>
        </p: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D4DF993B-D1CF-0245-33FA-0705F6761FBC}"/>
                </a:ext>
              </a:extLst>
            </p:cNvPr>
            <p:cNvCxnSpPr/>
            <p:nvPr/>
          </p:nvCxnSpPr>
          <p:spPr>
            <a:xfrm>
              <a:off x="11556474" y="1062702"/>
              <a:ext cx="1202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F0537A02-EB0E-F6FE-0E9E-103F84DDF32D}"/>
                </a:ext>
              </a:extLst>
            </p:cNvPr>
            <p:cNvSpPr/>
            <p:nvPr/>
          </p:nvSpPr>
          <p:spPr>
            <a:xfrm>
              <a:off x="3798061" y="576470"/>
              <a:ext cx="8182837" cy="64943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45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3EB067B8-A7FD-9AC5-FBBE-0161C57B7EE6}"/>
                </a:ext>
              </a:extLst>
            </p:cNvPr>
            <p:cNvSpPr txBox="1"/>
            <p:nvPr/>
          </p:nvSpPr>
          <p:spPr>
            <a:xfrm>
              <a:off x="3664749" y="189314"/>
              <a:ext cx="2391375" cy="4528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45" dirty="0"/>
                <a:t>Collagen 1 triple Helix</a:t>
              </a:r>
            </a:p>
          </p:txBody>
        </p:sp>
      </p:grpSp>
      <p:sp>
        <p:nvSpPr>
          <p:cNvPr id="103" name="TextBox 102">
            <a:extLst>
              <a:ext uri="{FF2B5EF4-FFF2-40B4-BE49-F238E27FC236}">
                <a16:creationId xmlns:a16="http://schemas.microsoft.com/office/drawing/2014/main" id="{01FB1E6A-AA86-9544-1BCF-22E47AA300D9}"/>
              </a:ext>
            </a:extLst>
          </p:cNvPr>
          <p:cNvSpPr txBox="1"/>
          <p:nvPr/>
        </p:nvSpPr>
        <p:spPr>
          <a:xfrm>
            <a:off x="8823" y="3045834"/>
            <a:ext cx="287258" cy="2377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45" dirty="0"/>
              <a:t>B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5CBA80-86B4-6AFE-7FD3-8A0013239EAB}"/>
              </a:ext>
            </a:extLst>
          </p:cNvPr>
          <p:cNvSpPr txBox="1"/>
          <p:nvPr/>
        </p:nvSpPr>
        <p:spPr>
          <a:xfrm>
            <a:off x="5110084" y="3539671"/>
            <a:ext cx="269626" cy="1812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78" b="1" dirty="0">
                <a:latin typeface="Arial" panose="020B0604020202020204" pitchFamily="34" charset="0"/>
                <a:cs typeface="Arial" panose="020B0604020202020204" pitchFamily="34" charset="0"/>
              </a:rPr>
              <a:t>⍺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41B997-4392-1553-AFCE-AB53072D0929}"/>
              </a:ext>
            </a:extLst>
          </p:cNvPr>
          <p:cNvSpPr txBox="1"/>
          <p:nvPr/>
        </p:nvSpPr>
        <p:spPr>
          <a:xfrm>
            <a:off x="5111960" y="3663544"/>
            <a:ext cx="269626" cy="1812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78" b="1" dirty="0">
                <a:latin typeface="Arial" panose="020B0604020202020204" pitchFamily="34" charset="0"/>
                <a:cs typeface="Arial" panose="020B0604020202020204" pitchFamily="34" charset="0"/>
              </a:rPr>
              <a:t>⍺2</a:t>
            </a:r>
          </a:p>
        </p:txBody>
      </p:sp>
      <p:sp>
        <p:nvSpPr>
          <p:cNvPr id="5" name="Right Bracket 4">
            <a:extLst>
              <a:ext uri="{FF2B5EF4-FFF2-40B4-BE49-F238E27FC236}">
                <a16:creationId xmlns:a16="http://schemas.microsoft.com/office/drawing/2014/main" id="{525A96F3-F79C-7738-822E-89566244B6DF}"/>
              </a:ext>
            </a:extLst>
          </p:cNvPr>
          <p:cNvSpPr/>
          <p:nvPr/>
        </p:nvSpPr>
        <p:spPr>
          <a:xfrm>
            <a:off x="5127459" y="3591066"/>
            <a:ext cx="24002" cy="78093"/>
          </a:xfrm>
          <a:prstGeom prst="righ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45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1C33BC30-5AC3-753A-35B1-3FB0FEEAAAEF}"/>
              </a:ext>
            </a:extLst>
          </p:cNvPr>
          <p:cNvCxnSpPr/>
          <p:nvPr/>
        </p:nvCxnSpPr>
        <p:spPr>
          <a:xfrm>
            <a:off x="5123884" y="3759007"/>
            <a:ext cx="631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D03C729-FA80-1BB4-FCF2-897D6F9EF989}"/>
              </a:ext>
            </a:extLst>
          </p:cNvPr>
          <p:cNvSpPr txBox="1"/>
          <p:nvPr/>
        </p:nvSpPr>
        <p:spPr>
          <a:xfrm>
            <a:off x="3174607" y="1960335"/>
            <a:ext cx="58005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3477543-8378-0BE7-F175-2929873A3BC3}"/>
              </a:ext>
            </a:extLst>
          </p:cNvPr>
          <p:cNvSpPr txBox="1"/>
          <p:nvPr/>
        </p:nvSpPr>
        <p:spPr>
          <a:xfrm>
            <a:off x="2329440" y="3366192"/>
            <a:ext cx="95819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PG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B2054274-83F7-C612-2494-3B502D78C6DC}"/>
              </a:ext>
            </a:extLst>
          </p:cNvPr>
          <p:cNvSpPr/>
          <p:nvPr/>
        </p:nvSpPr>
        <p:spPr>
          <a:xfrm>
            <a:off x="64608" y="3091069"/>
            <a:ext cx="6222916" cy="1347496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B1D14E4-4942-1F9D-6974-2AEB7ED507F5}"/>
              </a:ext>
            </a:extLst>
          </p:cNvPr>
          <p:cNvSpPr/>
          <p:nvPr/>
        </p:nvSpPr>
        <p:spPr>
          <a:xfrm>
            <a:off x="64608" y="1732230"/>
            <a:ext cx="6222916" cy="1361482"/>
          </a:xfrm>
          <a:prstGeom prst="rect">
            <a:avLst/>
          </a:prstGeom>
          <a:noFill/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01387A1-6B51-FB99-DEED-E90CD8EEB2AA}"/>
              </a:ext>
            </a:extLst>
          </p:cNvPr>
          <p:cNvGrpSpPr/>
          <p:nvPr/>
        </p:nvGrpSpPr>
        <p:grpSpPr>
          <a:xfrm>
            <a:off x="1114086" y="2069538"/>
            <a:ext cx="753352" cy="980027"/>
            <a:chOff x="1114086" y="2069538"/>
            <a:chExt cx="753352" cy="980027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C62D1E6-7788-2151-1694-84846F307C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/>
            <a:srcRect l="10231" t="13273"/>
            <a:stretch/>
          </p:blipFill>
          <p:spPr>
            <a:xfrm>
              <a:off x="1215112" y="2069538"/>
              <a:ext cx="652326" cy="980027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D36F815-DEDC-CC8C-8443-AC437CED77C1}"/>
                </a:ext>
              </a:extLst>
            </p:cNvPr>
            <p:cNvSpPr txBox="1"/>
            <p:nvPr/>
          </p:nvSpPr>
          <p:spPr>
            <a:xfrm rot="16200000">
              <a:off x="841896" y="2370231"/>
              <a:ext cx="71365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Intensity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2142D474-F8D6-415D-0B92-37A576A2634E}"/>
              </a:ext>
            </a:extLst>
          </p:cNvPr>
          <p:cNvGrpSpPr/>
          <p:nvPr/>
        </p:nvGrpSpPr>
        <p:grpSpPr>
          <a:xfrm>
            <a:off x="1116608" y="3392122"/>
            <a:ext cx="760069" cy="996721"/>
            <a:chOff x="1116608" y="3392122"/>
            <a:chExt cx="760069" cy="996721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80BD9948-5646-DB39-6107-BA0D8D0620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/>
            <a:srcRect l="10615" t="10862"/>
            <a:stretch/>
          </p:blipFill>
          <p:spPr>
            <a:xfrm>
              <a:off x="1242332" y="3392122"/>
              <a:ext cx="634345" cy="996721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869EE88-AF4F-F40B-E340-69C64406A7E9}"/>
                </a:ext>
              </a:extLst>
            </p:cNvPr>
            <p:cNvSpPr txBox="1"/>
            <p:nvPr/>
          </p:nvSpPr>
          <p:spPr>
            <a:xfrm rot="16200000">
              <a:off x="844418" y="3739961"/>
              <a:ext cx="71365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Intens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61605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316</Words>
  <Application>Microsoft Macintosh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ArialNarro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 Schurman</dc:creator>
  <cp:lastModifiedBy>Charlie Schurman</cp:lastModifiedBy>
  <cp:revision>7</cp:revision>
  <dcterms:created xsi:type="dcterms:W3CDTF">2024-03-07T00:22:26Z</dcterms:created>
  <dcterms:modified xsi:type="dcterms:W3CDTF">2025-09-12T22:31:13Z</dcterms:modified>
</cp:coreProperties>
</file>